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973F02-F91A-4C10-8FA8-90A6BDBA25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4C5EBA-BA51-46EA-ABA2-BC13CBFCDB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D70A4C-F330-419F-AD09-18B55068B5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920077-86D9-48B6-B78F-1049BB29D8B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0196E5-05BF-4EAE-BBE6-CD912B3115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24126F-D5FD-4814-9233-BF476FB055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A47DCF-158C-4963-B2F2-B959A7FC24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FEFC81-653F-4575-A870-FEC83D5053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42F6B9-BFF2-40FC-A6CB-10BBA57BFF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194529-1E96-4CD3-83C1-2018EA0852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9603EE-BB3F-4DDC-BE06-65A87BDB87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C5997C-669F-47C4-A92C-B38A5F8D42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C6DBDAD-8EE7-4B27-B1A0-A186BB2DAA6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ZoneTexte 4"/>
          <p:cNvSpPr/>
          <p:nvPr/>
        </p:nvSpPr>
        <p:spPr>
          <a:xfrm>
            <a:off x="7166160" y="6467400"/>
            <a:ext cx="166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ry Figure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ZoneTexte 6"/>
          <p:cNvSpPr/>
          <p:nvPr/>
        </p:nvSpPr>
        <p:spPr>
          <a:xfrm>
            <a:off x="3159720" y="5056200"/>
            <a:ext cx="207504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HIR – CHIR-124 2x1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Calibri"/>
              </a:rPr>
              <a:t>-8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M – Gemcitabine 1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Calibri"/>
              </a:rPr>
              <a:t>-7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+C – Gem + CHI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ZoneTexte 7"/>
          <p:cNvSpPr/>
          <p:nvPr/>
        </p:nvSpPr>
        <p:spPr>
          <a:xfrm rot="16200000">
            <a:off x="178920" y="3033720"/>
            <a:ext cx="2752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Percentage of spheroids sectio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Graphique 17" descr=""/>
          <p:cNvPicPr/>
          <p:nvPr/>
        </p:nvPicPr>
        <p:blipFill>
          <a:blip r:embed="rId1"/>
          <a:stretch/>
        </p:blipFill>
        <p:spPr>
          <a:xfrm>
            <a:off x="1609560" y="1481040"/>
            <a:ext cx="5577120" cy="3517920"/>
          </a:xfrm>
          <a:prstGeom prst="rect">
            <a:avLst/>
          </a:prstGeom>
          <a:ln w="0">
            <a:noFill/>
          </a:ln>
        </p:spPr>
      </p:pic>
      <p:sp>
        <p:nvSpPr>
          <p:cNvPr id="45" name="ZoneTexte 19"/>
          <p:cNvSpPr/>
          <p:nvPr/>
        </p:nvSpPr>
        <p:spPr>
          <a:xfrm>
            <a:off x="6151320" y="2227320"/>
            <a:ext cx="21834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umber of PARP-C positive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ells per sec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23T08:25:49Z</dcterms:created>
  <dc:creator>Bernard DUCOMMUN</dc:creator>
  <dc:description/>
  <cp:keywords/>
  <dc:language>en-US</dc:language>
  <cp:lastModifiedBy>Bernard DUCOMMUN</cp:lastModifiedBy>
  <cp:lastPrinted>2011-11-23T12:30:59Z</cp:lastPrinted>
  <dcterms:modified xsi:type="dcterms:W3CDTF">2011-11-24T07:49:26Z</dcterms:modified>
  <cp:revision>10</cp:revision>
  <dc:subject/>
  <dc:title>Présentation PowerPoint</dc:title>
</cp:coreProperties>
</file>